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6" autoAdjust="0"/>
    <p:restoredTop sz="94660"/>
  </p:normalViewPr>
  <p:slideViewPr>
    <p:cSldViewPr snapToGrid="0">
      <p:cViewPr>
        <p:scale>
          <a:sx n="80" d="100"/>
          <a:sy n="80" d="100"/>
        </p:scale>
        <p:origin x="834" y="-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1801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589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680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119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19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7735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2592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8926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726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340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1744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A7843-EFB1-4F11-B6D8-29AF3F28DED9}" type="datetimeFigureOut">
              <a:rPr kumimoji="1" lang="ja-JP" altLang="en-US" smtClean="0"/>
              <a:t>2024/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4F2ED-97C9-4DC3-8BFB-3F649578C8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173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9">
            <a:extLst>
              <a:ext uri="{FF2B5EF4-FFF2-40B4-BE49-F238E27FC236}">
                <a16:creationId xmlns:a16="http://schemas.microsoft.com/office/drawing/2014/main" id="{F776B6A2-4668-D34B-2609-FCE6978124F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34" r="5917" b="31937"/>
          <a:stretch/>
        </p:blipFill>
        <p:spPr bwMode="auto">
          <a:xfrm>
            <a:off x="1459832" y="2479842"/>
            <a:ext cx="2767263" cy="2168358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61">
            <a:extLst>
              <a:ext uri="{FF2B5EF4-FFF2-40B4-BE49-F238E27FC236}">
                <a16:creationId xmlns:a16="http://schemas.microsoft.com/office/drawing/2014/main" id="{A57A4FC3-6DF3-2004-5EDE-66000034B7F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061" r="6402" b="12531"/>
          <a:stretch/>
        </p:blipFill>
        <p:spPr bwMode="auto">
          <a:xfrm>
            <a:off x="4916907" y="2479842"/>
            <a:ext cx="2767263" cy="2168358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 Box 118">
            <a:extLst>
              <a:ext uri="{FF2B5EF4-FFF2-40B4-BE49-F238E27FC236}">
                <a16:creationId xmlns:a16="http://schemas.microsoft.com/office/drawing/2014/main" id="{C9F8C3EE-A9F5-6CDA-780F-A0614D5E8E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72373" y="3080412"/>
            <a:ext cx="64573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just"/>
            <a:r>
              <a:rPr lang="en-GB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850 bp</a:t>
            </a:r>
            <a:endParaRPr lang="ja-JP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Text Box 119">
            <a:extLst>
              <a:ext uri="{FF2B5EF4-FFF2-40B4-BE49-F238E27FC236}">
                <a16:creationId xmlns:a16="http://schemas.microsoft.com/office/drawing/2014/main" id="{E819EB20-79C6-6EE2-8150-16DE8B2F73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72373" y="3329333"/>
            <a:ext cx="585415" cy="350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just"/>
            <a:r>
              <a:rPr lang="en-GB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50 bp</a:t>
            </a:r>
            <a:endParaRPr lang="ja-JP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9" name="AutoShape 120">
            <a:extLst>
              <a:ext uri="{FF2B5EF4-FFF2-40B4-BE49-F238E27FC236}">
                <a16:creationId xmlns:a16="http://schemas.microsoft.com/office/drawing/2014/main" id="{4808126E-579B-6113-B6F7-AEF00E10A38E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020793" y="3229611"/>
            <a:ext cx="787388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" name="AutoShape 121">
            <a:extLst>
              <a:ext uri="{FF2B5EF4-FFF2-40B4-BE49-F238E27FC236}">
                <a16:creationId xmlns:a16="http://schemas.microsoft.com/office/drawing/2014/main" id="{559552EE-F014-A6CA-0F5A-B6B5DCE7315B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6106602" y="3369310"/>
            <a:ext cx="1701579" cy="135283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" name="Text Box 112">
            <a:extLst>
              <a:ext uri="{FF2B5EF4-FFF2-40B4-BE49-F238E27FC236}">
                <a16:creationId xmlns:a16="http://schemas.microsoft.com/office/drawing/2014/main" id="{8A008611-A005-68D5-216A-58AEBFADCA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57273" y="3970597"/>
            <a:ext cx="624319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just"/>
            <a:r>
              <a:rPr lang="en-GB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01 bp</a:t>
            </a:r>
            <a:endParaRPr lang="ja-JP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6" name="Text Box 113">
            <a:extLst>
              <a:ext uri="{FF2B5EF4-FFF2-40B4-BE49-F238E27FC236}">
                <a16:creationId xmlns:a16="http://schemas.microsoft.com/office/drawing/2014/main" id="{A6BB20D5-9382-4A32-D989-A0385B489F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7862" y="3534271"/>
            <a:ext cx="659143" cy="3124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just"/>
            <a:r>
              <a:rPr lang="en-GB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04 bp</a:t>
            </a:r>
            <a:endParaRPr lang="ja-JP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7" name="Text Box 114">
            <a:extLst>
              <a:ext uri="{FF2B5EF4-FFF2-40B4-BE49-F238E27FC236}">
                <a16:creationId xmlns:a16="http://schemas.microsoft.com/office/drawing/2014/main" id="{9AFEEFE2-883A-3EA0-DE50-33870CE17C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1290" y="3261360"/>
            <a:ext cx="616062" cy="335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just"/>
            <a:r>
              <a:rPr lang="en-GB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25 bp</a:t>
            </a:r>
            <a:endParaRPr lang="ja-JP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18" name="AutoShape 120">
            <a:extLst>
              <a:ext uri="{FF2B5EF4-FFF2-40B4-BE49-F238E27FC236}">
                <a16:creationId xmlns:a16="http://schemas.microsoft.com/office/drawing/2014/main" id="{DB50E27B-8E85-FB22-AED6-6A99C2217EAF}"/>
              </a:ext>
            </a:extLst>
          </p:cNvPr>
          <p:cNvCxnSpPr>
            <a:cxnSpLocks noChangeShapeType="1"/>
            <a:stCxn id="17" idx="1"/>
          </p:cNvCxnSpPr>
          <p:nvPr/>
        </p:nvCxnSpPr>
        <p:spPr bwMode="auto">
          <a:xfrm flipH="1">
            <a:off x="3632147" y="3429000"/>
            <a:ext cx="659143" cy="213828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" name="AutoShape 120">
            <a:extLst>
              <a:ext uri="{FF2B5EF4-FFF2-40B4-BE49-F238E27FC236}">
                <a16:creationId xmlns:a16="http://schemas.microsoft.com/office/drawing/2014/main" id="{1B015AF8-FEAA-EC69-2836-D84ECFB47F90}"/>
              </a:ext>
            </a:extLst>
          </p:cNvPr>
          <p:cNvCxnSpPr>
            <a:cxnSpLocks noChangeShapeType="1"/>
            <a:stCxn id="16" idx="1"/>
          </p:cNvCxnSpPr>
          <p:nvPr/>
        </p:nvCxnSpPr>
        <p:spPr bwMode="auto">
          <a:xfrm flipH="1">
            <a:off x="3846915" y="3690481"/>
            <a:ext cx="450947" cy="10855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6" name="AutoShape 120">
            <a:extLst>
              <a:ext uri="{FF2B5EF4-FFF2-40B4-BE49-F238E27FC236}">
                <a16:creationId xmlns:a16="http://schemas.microsoft.com/office/drawing/2014/main" id="{34401D4E-1A76-8AD0-D53A-1AB1890F9174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848519" y="4115060"/>
            <a:ext cx="434327" cy="186264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1D20907-E0F5-3735-3866-53574C5DD073}"/>
              </a:ext>
            </a:extLst>
          </p:cNvPr>
          <p:cNvSpPr txBox="1"/>
          <p:nvPr/>
        </p:nvSpPr>
        <p:spPr>
          <a:xfrm>
            <a:off x="825676" y="962762"/>
            <a:ext cx="23866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 Figure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DDB63A3-FAF9-4D83-116F-23E6F4B35F3C}"/>
              </a:ext>
            </a:extLst>
          </p:cNvPr>
          <p:cNvSpPr txBox="1"/>
          <p:nvPr/>
        </p:nvSpPr>
        <p:spPr>
          <a:xfrm>
            <a:off x="1396224" y="1838006"/>
            <a:ext cx="5916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(a)</a:t>
            </a:r>
            <a:endParaRPr kumimoji="1" lang="ja-JP" altLang="en-US" sz="16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6AEE272-F2E7-7DE4-7F0B-21FFA604D843}"/>
              </a:ext>
            </a:extLst>
          </p:cNvPr>
          <p:cNvSpPr txBox="1"/>
          <p:nvPr/>
        </p:nvSpPr>
        <p:spPr>
          <a:xfrm>
            <a:off x="4845348" y="1838006"/>
            <a:ext cx="5916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(b)</a:t>
            </a:r>
            <a:endParaRPr kumimoji="1" lang="ja-JP" altLang="en-US" sz="16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D7C5CAD-26C5-0776-F033-65F88E6B04D7}"/>
              </a:ext>
            </a:extLst>
          </p:cNvPr>
          <p:cNvSpPr txBox="1"/>
          <p:nvPr/>
        </p:nvSpPr>
        <p:spPr>
          <a:xfrm>
            <a:off x="962108" y="4841103"/>
            <a:ext cx="6722062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ja-JP" sz="105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1   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etection of mutations in 23S rRNA and </a:t>
            </a:r>
            <a:r>
              <a:rPr lang="en-GB" altLang="ja-JP" sz="1050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dxA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ssociated with resistance to clarithromycin and metronidazole, respectively. (a) </a:t>
            </a:r>
            <a:r>
              <a:rPr lang="en-US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CR-RFLP analysis</a:t>
            </a:r>
            <a:r>
              <a:rPr lang="ja-JP" altLang="en-US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f</a:t>
            </a:r>
            <a:r>
              <a:rPr lang="ja-JP" altLang="en-US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3S rRNA. 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</a:t>
            </a:r>
            <a:r>
              <a:rPr lang="en-GB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he presence of A2147G mutation, two fragments (304-bp and 101-bp) (Lane-6, 8, 10) are 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enerated by </a:t>
            </a:r>
            <a:r>
              <a:rPr lang="en-GB" altLang="ja-JP" sz="1050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saI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digestion of </a:t>
            </a:r>
            <a:r>
              <a:rPr lang="en-GB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CR products (425bp) from 23S rRNA. (b) PCR products from partial </a:t>
            </a:r>
            <a:r>
              <a:rPr lang="en-GB" altLang="ja-JP" sz="105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dxA</a:t>
            </a:r>
            <a:r>
              <a:rPr lang="en-GB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ene. 650-bp product (Lane-4, 5, 10) represents deletion of 200-bp from 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tact gene showing</a:t>
            </a:r>
            <a:r>
              <a:rPr lang="en-GB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850-bp products. (Lane-1,6,11-DNA size marker)</a:t>
            </a:r>
            <a:r>
              <a:rPr lang="en-GB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 </a:t>
            </a:r>
            <a:endParaRPr kumimoji="1" lang="ja-JP" altLang="en-US" sz="105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00683D3-FBFB-632B-072F-4DBDF63CA0E7}"/>
              </a:ext>
            </a:extLst>
          </p:cNvPr>
          <p:cNvSpPr txBox="1"/>
          <p:nvPr/>
        </p:nvSpPr>
        <p:spPr>
          <a:xfrm>
            <a:off x="1526771" y="2204812"/>
            <a:ext cx="2767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   2    3    4    5     6    7    8    9    10  11 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FDD41EF-B64C-5870-FDAF-0A26679AE5E3}"/>
              </a:ext>
            </a:extLst>
          </p:cNvPr>
          <p:cNvSpPr txBox="1"/>
          <p:nvPr/>
        </p:nvSpPr>
        <p:spPr>
          <a:xfrm>
            <a:off x="4975895" y="2204812"/>
            <a:ext cx="2767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   2    3    4    5    6    7   8    9   10  11 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31C3A57-DF62-AD22-1E82-AC727A49EF8B}"/>
              </a:ext>
            </a:extLst>
          </p:cNvPr>
          <p:cNvSpPr txBox="1"/>
          <p:nvPr/>
        </p:nvSpPr>
        <p:spPr>
          <a:xfrm>
            <a:off x="890679" y="3389177"/>
            <a:ext cx="5684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57D3A9EF-55F0-D517-6389-3987E88CA395}"/>
              </a:ext>
            </a:extLst>
          </p:cNvPr>
          <p:cNvCxnSpPr/>
          <p:nvPr/>
        </p:nvCxnSpPr>
        <p:spPr>
          <a:xfrm>
            <a:off x="1371627" y="3504593"/>
            <a:ext cx="127222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89C1DEB-761B-0B3C-8DCC-D7F36BFCD2D5}"/>
              </a:ext>
            </a:extLst>
          </p:cNvPr>
          <p:cNvSpPr txBox="1"/>
          <p:nvPr/>
        </p:nvSpPr>
        <p:spPr>
          <a:xfrm>
            <a:off x="825676" y="3032690"/>
            <a:ext cx="6240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ABCE5FD9-358C-E288-4DE0-8A1997FE970C}"/>
              </a:ext>
            </a:extLst>
          </p:cNvPr>
          <p:cNvCxnSpPr/>
          <p:nvPr/>
        </p:nvCxnSpPr>
        <p:spPr>
          <a:xfrm>
            <a:off x="1366323" y="3157382"/>
            <a:ext cx="127222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260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391</TotalTime>
  <Words>145</Words>
  <Application>Microsoft Office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宣道 小林</dc:creator>
  <cp:lastModifiedBy>宣道 小林</cp:lastModifiedBy>
  <cp:revision>8</cp:revision>
  <cp:lastPrinted>2023-12-30T02:36:49Z</cp:lastPrinted>
  <dcterms:created xsi:type="dcterms:W3CDTF">2023-12-26T04:31:29Z</dcterms:created>
  <dcterms:modified xsi:type="dcterms:W3CDTF">2024-02-03T03:55:09Z</dcterms:modified>
</cp:coreProperties>
</file>